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12193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D87F1E-9A91-4BEA-BC7C-60C6C49F7A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105156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7285320"/>
            <a:ext cx="105156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FD5A04-1949-41F1-9EDD-5CD14BAAB4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94B38-4D24-4499-A8A0-F8C81EA6B8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3244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3244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7285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7285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7285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EA80CC-EFFB-47AE-99EE-C6520E1C43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3244320"/>
            <a:ext cx="10515600" cy="773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338"/>
              </a:spcBef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DA7B92-050C-43A9-A667-1C1ED2E67B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105156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1FD060-FC44-414C-BCD1-CAE5523E7F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657433-AEE5-47AE-A2B8-B4A3456C1E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464009-9AAA-4841-BDFB-B0A74B045C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649440"/>
            <a:ext cx="10515600" cy="10921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338"/>
              </a:spcBef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8FE0C7-5C7E-4E96-B61E-2CD09E6A21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62DD18-31D1-4A3E-B490-420518C806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0336D-A173-4C81-AD97-7CC0596EC2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7285320"/>
            <a:ext cx="105156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65050-9C87-44C6-B01B-47DC18EDBD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58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3244320"/>
            <a:ext cx="105156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312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1" marL="9129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2" marL="152244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3" marL="213192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4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5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6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11299680"/>
            <a:ext cx="27432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600" spc="-1" strike="noStrike">
                <a:solidFill>
                  <a:srgbClr val="898989"/>
                </a:solidFill>
                <a:latin typeface="Calibri"/>
                <a:ea typeface="Yu Gothic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600" spc="-1" strike="noStrike">
                <a:solidFill>
                  <a:srgbClr val="898989"/>
                </a:solidFill>
                <a:latin typeface="Calibri"/>
                <a:ea typeface="Yu Gothic"/>
              </a:rPr>
              <a:t>&lt;date/time&gt;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11299680"/>
            <a:ext cx="41148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11299680"/>
            <a:ext cx="27432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600" spc="-1" strike="noStrike">
                <a:solidFill>
                  <a:srgbClr val="898989"/>
                </a:solidFill>
                <a:latin typeface="Calibri"/>
                <a:ea typeface="Yu Gothic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0EB372E-5595-434A-9C8B-442AA126A5AC}" type="slidenum">
              <a:rPr b="0" lang="ja-JP" sz="1600" spc="-1" strike="noStrike">
                <a:solidFill>
                  <a:srgbClr val="898989"/>
                </a:solidFill>
                <a:latin typeface="Calibri"/>
                <a:ea typeface="Yu Gothic"/>
              </a:rPr>
              <a:t>&lt;number&gt;</a:t>
            </a:fld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"/>
          <p:cNvSpPr/>
          <p:nvPr/>
        </p:nvSpPr>
        <p:spPr>
          <a:xfrm>
            <a:off x="693720" y="1879560"/>
            <a:ext cx="10863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Yu Gothic"/>
              </a:rPr>
              <a:t>Supplementary Material 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Yu Gothic"/>
              </a:rPr>
              <a:t>.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Yu Gothic"/>
              </a:rPr>
              <a:t>Distribution of age at smoking initiation and age at lung cancer diagnosis among men (A) and women (B) (based on National Insurance Health Service data)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10"/>
          <p:cNvGrpSpPr/>
          <p:nvPr/>
        </p:nvGrpSpPr>
        <p:grpSpPr>
          <a:xfrm>
            <a:off x="693720" y="2855880"/>
            <a:ext cx="5486400" cy="5924520"/>
            <a:chOff x="693720" y="2855880"/>
            <a:chExt cx="5486400" cy="5924520"/>
          </a:xfrm>
        </p:grpSpPr>
        <p:sp>
          <p:nvSpPr>
            <p:cNvPr id="43" name="テキスト ボックス 4"/>
            <p:cNvSpPr/>
            <p:nvPr/>
          </p:nvSpPr>
          <p:spPr>
            <a:xfrm>
              <a:off x="698400" y="2855880"/>
              <a:ext cx="4244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Yu Gothic"/>
                </a:rPr>
                <a:t>A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4" name="Chart 1" descr=""/>
            <p:cNvPicPr/>
            <p:nvPr/>
          </p:nvPicPr>
          <p:blipFill>
            <a:blip r:embed="rId1"/>
            <a:stretch/>
          </p:blipFill>
          <p:spPr>
            <a:xfrm>
              <a:off x="693720" y="3291840"/>
              <a:ext cx="5486400" cy="54885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5" name="Group 11"/>
          <p:cNvGrpSpPr/>
          <p:nvPr/>
        </p:nvGrpSpPr>
        <p:grpSpPr>
          <a:xfrm>
            <a:off x="6329520" y="2855880"/>
            <a:ext cx="5486400" cy="5921280"/>
            <a:chOff x="6329520" y="2855880"/>
            <a:chExt cx="5486400" cy="5921280"/>
          </a:xfrm>
        </p:grpSpPr>
        <p:sp>
          <p:nvSpPr>
            <p:cNvPr id="46" name="テキスト ボックス 4"/>
            <p:cNvSpPr/>
            <p:nvPr/>
          </p:nvSpPr>
          <p:spPr>
            <a:xfrm>
              <a:off x="6330960" y="2855880"/>
              <a:ext cx="4251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Yu Gothic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7" name="Chart 3" descr=""/>
            <p:cNvPicPr/>
            <p:nvPr/>
          </p:nvPicPr>
          <p:blipFill>
            <a:blip r:embed="rId2"/>
            <a:stretch/>
          </p:blipFill>
          <p:spPr>
            <a:xfrm>
              <a:off x="6329520" y="3291480"/>
              <a:ext cx="5486400" cy="54856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11-08T14:40:59Z</dcterms:created>
  <dc:creator>JE editorial office</dc:creator>
  <dc:description/>
  <dc:language>en-US</dc:language>
  <cp:lastModifiedBy>이제인</cp:lastModifiedBy>
  <dcterms:modified xsi:type="dcterms:W3CDTF">2026-05-28T04:14:55Z</dcterms:modified>
  <cp:revision>4</cp:revision>
  <dc:subject/>
  <dc:title>PowerPoint プレゼンテーション</dc:title>
</cp:coreProperties>
</file>